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98" r:id="rId2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6C0A"/>
    <a:srgbClr val="77933C"/>
    <a:srgbClr val="F070B3"/>
    <a:srgbClr val="A9D18E"/>
    <a:srgbClr val="F23EDD"/>
    <a:srgbClr val="01B601"/>
    <a:srgbClr val="FF6200"/>
    <a:srgbClr val="FFD8BE"/>
    <a:srgbClr val="00B72E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65" autoAdjust="0"/>
    <p:restoredTop sz="95220" autoAdjust="0"/>
  </p:normalViewPr>
  <p:slideViewPr>
    <p:cSldViewPr snapToGrid="0">
      <p:cViewPr varScale="1">
        <p:scale>
          <a:sx n="54" d="100"/>
          <a:sy n="54" d="100"/>
        </p:scale>
        <p:origin x="271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&#24037;&#20316;1\2-&#22312;&#30740;&#39033;&#30446;\2-NO%20and%20Gdpd2\66-Figure\&#23567;&#40736;&#32454;&#32990;&#20122;&#32676;&#27604;&#2036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作图lub亚群合并!$K$4</c:f>
              <c:strCache>
                <c:ptCount val="1"/>
                <c:pt idx="0">
                  <c:v>PBS</c:v>
                </c:pt>
              </c:strCache>
            </c:strRef>
          </c:tx>
          <c:spPr>
            <a:solidFill>
              <a:srgbClr val="D3B265"/>
            </a:solidFill>
            <a:ln>
              <a:noFill/>
            </a:ln>
            <a:effectLst/>
          </c:spPr>
          <c:invertIfNegative val="0"/>
          <c:cat>
            <c:strRef>
              <c:f>作图lub亚群合并!$J$5:$J$7</c:f>
              <c:strCache>
                <c:ptCount val="3"/>
                <c:pt idx="0">
                  <c:v>Quiescent club</c:v>
                </c:pt>
                <c:pt idx="1">
                  <c:v>Apoptotic club</c:v>
                </c:pt>
                <c:pt idx="2">
                  <c:v>Proliferative club</c:v>
                </c:pt>
              </c:strCache>
            </c:strRef>
          </c:cat>
          <c:val>
            <c:numRef>
              <c:f>作图lub亚群合并!$K$5:$K$7</c:f>
              <c:numCache>
                <c:formatCode>0.0</c:formatCode>
                <c:ptCount val="3"/>
                <c:pt idx="0">
                  <c:v>70.454545454545453</c:v>
                </c:pt>
                <c:pt idx="1">
                  <c:v>18.181818181818183</c:v>
                </c:pt>
                <c:pt idx="2">
                  <c:v>11.3636363636363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5D-4550-8D53-3779567221C4}"/>
            </c:ext>
          </c:extLst>
        </c:ser>
        <c:ser>
          <c:idx val="1"/>
          <c:order val="1"/>
          <c:tx>
            <c:strRef>
              <c:f>作图lub亚群合并!$L$4</c:f>
              <c:strCache>
                <c:ptCount val="1"/>
                <c:pt idx="0">
                  <c:v>OVA</c:v>
                </c:pt>
              </c:strCache>
            </c:strRef>
          </c:tx>
          <c:spPr>
            <a:solidFill>
              <a:srgbClr val="082E5A"/>
            </a:solidFill>
            <a:ln>
              <a:noFill/>
            </a:ln>
            <a:effectLst/>
          </c:spPr>
          <c:invertIfNegative val="0"/>
          <c:cat>
            <c:strRef>
              <c:f>作图lub亚群合并!$J$5:$J$7</c:f>
              <c:strCache>
                <c:ptCount val="3"/>
                <c:pt idx="0">
                  <c:v>Quiescent club</c:v>
                </c:pt>
                <c:pt idx="1">
                  <c:v>Apoptotic club</c:v>
                </c:pt>
                <c:pt idx="2">
                  <c:v>Proliferative club</c:v>
                </c:pt>
              </c:strCache>
            </c:strRef>
          </c:cat>
          <c:val>
            <c:numRef>
              <c:f>作图lub亚群合并!$L$5:$L$7</c:f>
              <c:numCache>
                <c:formatCode>0.0</c:formatCode>
                <c:ptCount val="3"/>
                <c:pt idx="0">
                  <c:v>33.333333333333329</c:v>
                </c:pt>
                <c:pt idx="1">
                  <c:v>44.444444444444443</c:v>
                </c:pt>
                <c:pt idx="2">
                  <c:v>22.222222222222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5D-4550-8D53-3779567221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74352144"/>
        <c:axId val="1233558000"/>
      </c:barChart>
      <c:catAx>
        <c:axId val="474352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33558000"/>
        <c:crosses val="autoZero"/>
        <c:auto val="1"/>
        <c:lblAlgn val="ctr"/>
        <c:lblOffset val="100"/>
        <c:noMultiLvlLbl val="0"/>
      </c:catAx>
      <c:valAx>
        <c:axId val="123355800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7435214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29721-A363-4FA3-9E2C-56891A475333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2F335-5CFE-4E61-B7FF-9AF214C2F7E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7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0"/>
            <a:ext cx="5669756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2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2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5"/>
            <a:ext cx="6520220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2620980"/>
            <a:ext cx="3213847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8" y="1539427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8" y="1539427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2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chart" Target="../charts/chart1.xml"/><Relationship Id="rId10" Type="http://schemas.openxmlformats.org/officeDocument/2006/relationships/image" Target="../media/image8.jpeg"/><Relationship Id="rId4" Type="http://schemas.openxmlformats.org/officeDocument/2006/relationships/image" Target="../media/image3.tiff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组合 93">
            <a:extLst>
              <a:ext uri="{FF2B5EF4-FFF2-40B4-BE49-F238E27FC236}">
                <a16:creationId xmlns:a16="http://schemas.microsoft.com/office/drawing/2014/main" id="{AAE78ECB-2A21-494D-0A02-2C53AD7F54A6}"/>
              </a:ext>
            </a:extLst>
          </p:cNvPr>
          <p:cNvGrpSpPr/>
          <p:nvPr/>
        </p:nvGrpSpPr>
        <p:grpSpPr>
          <a:xfrm>
            <a:off x="515768" y="181046"/>
            <a:ext cx="6782588" cy="7405914"/>
            <a:chOff x="515768" y="296456"/>
            <a:chExt cx="6782588" cy="7405914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634BD84C-86FE-D12D-C836-FB7B2BED7342}"/>
                </a:ext>
              </a:extLst>
            </p:cNvPr>
            <p:cNvGrpSpPr/>
            <p:nvPr/>
          </p:nvGrpSpPr>
          <p:grpSpPr>
            <a:xfrm>
              <a:off x="3983763" y="627829"/>
              <a:ext cx="1936412" cy="1595598"/>
              <a:chOff x="2075909" y="2793106"/>
              <a:chExt cx="1936412" cy="1595598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08C36494-9A45-B65E-BEF4-38CF8AE569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85" t="17406" r="1230" b="7378"/>
              <a:stretch/>
            </p:blipFill>
            <p:spPr>
              <a:xfrm>
                <a:off x="2214495" y="2793106"/>
                <a:ext cx="1797826" cy="1487876"/>
              </a:xfrm>
              <a:prstGeom prst="rect">
                <a:avLst/>
              </a:prstGeom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07FAE953-3862-B2C7-D68A-8C5DDC3C5563}"/>
                  </a:ext>
                </a:extLst>
              </p:cNvPr>
              <p:cNvSpPr txBox="1"/>
              <p:nvPr/>
            </p:nvSpPr>
            <p:spPr>
              <a:xfrm>
                <a:off x="2828837" y="4280982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C1366E2-93A0-FCA1-C069-3FBB9B22B8D5}"/>
                  </a:ext>
                </a:extLst>
              </p:cNvPr>
              <p:cNvSpPr txBox="1"/>
              <p:nvPr/>
            </p:nvSpPr>
            <p:spPr>
              <a:xfrm>
                <a:off x="3353567" y="4280982"/>
                <a:ext cx="26421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D430B021-4003-81FF-4348-6D319D959027}"/>
                  </a:ext>
                </a:extLst>
              </p:cNvPr>
              <p:cNvSpPr txBox="1"/>
              <p:nvPr/>
            </p:nvSpPr>
            <p:spPr>
              <a:xfrm>
                <a:off x="2165945" y="4280982"/>
                <a:ext cx="33603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5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B7ECFFA2-8368-4131-F52C-B123A21C767D}"/>
                  </a:ext>
                </a:extLst>
              </p:cNvPr>
              <p:cNvSpPr txBox="1"/>
              <p:nvPr/>
            </p:nvSpPr>
            <p:spPr>
              <a:xfrm>
                <a:off x="2075909" y="4153666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4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03DE85E4-6DB8-F826-85E5-6D6451FED6FA}"/>
                  </a:ext>
                </a:extLst>
              </p:cNvPr>
              <p:cNvSpPr txBox="1"/>
              <p:nvPr/>
            </p:nvSpPr>
            <p:spPr>
              <a:xfrm>
                <a:off x="2075909" y="3882050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-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5B88FBD3-8633-10F5-7A38-7DAAC0E208F9}"/>
                  </a:ext>
                </a:extLst>
              </p:cNvPr>
              <p:cNvSpPr txBox="1"/>
              <p:nvPr/>
            </p:nvSpPr>
            <p:spPr>
              <a:xfrm>
                <a:off x="2075909" y="3625592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5171BCB-C327-CD99-5E6F-05A4EA7B8B94}"/>
                  </a:ext>
                </a:extLst>
              </p:cNvPr>
              <p:cNvSpPr txBox="1"/>
              <p:nvPr/>
            </p:nvSpPr>
            <p:spPr>
              <a:xfrm>
                <a:off x="3352990" y="2827465"/>
                <a:ext cx="49285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 err="1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Pseudotime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2D71AA30-ADBA-800E-E1FA-93BE83951806}"/>
                  </a:ext>
                </a:extLst>
              </p:cNvPr>
              <p:cNvSpPr txBox="1"/>
              <p:nvPr/>
            </p:nvSpPr>
            <p:spPr>
              <a:xfrm>
                <a:off x="3280990" y="3093862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E23CBFD2-4016-9E1B-7BF9-CC8004FAA1D9}"/>
                  </a:ext>
                </a:extLst>
              </p:cNvPr>
              <p:cNvSpPr txBox="1"/>
              <p:nvPr/>
            </p:nvSpPr>
            <p:spPr>
              <a:xfrm>
                <a:off x="3510112" y="3093862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A55CD126-87CD-B18E-728D-B1C2AB5E2474}"/>
                  </a:ext>
                </a:extLst>
              </p:cNvPr>
              <p:cNvSpPr txBox="1"/>
              <p:nvPr/>
            </p:nvSpPr>
            <p:spPr>
              <a:xfrm>
                <a:off x="3747152" y="3093862"/>
                <a:ext cx="14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0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4479372C-4429-CDD3-AE39-B708D79F31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754" t="2429" r="25049" b="89817"/>
              <a:stretch/>
            </p:blipFill>
            <p:spPr>
              <a:xfrm rot="10800000">
                <a:off x="3326565" y="2922756"/>
                <a:ext cx="553684" cy="170363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56CC1355-EC8E-A151-F2C7-CC121991D401}"/>
                  </a:ext>
                </a:extLst>
              </p:cNvPr>
              <p:cNvSpPr txBox="1"/>
              <p:nvPr/>
            </p:nvSpPr>
            <p:spPr>
              <a:xfrm>
                <a:off x="2075909" y="3348288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68651A0B-6E94-2271-EA55-B2E63816BFCE}"/>
                  </a:ext>
                </a:extLst>
              </p:cNvPr>
              <p:cNvSpPr txBox="1"/>
              <p:nvPr/>
            </p:nvSpPr>
            <p:spPr>
              <a:xfrm>
                <a:off x="2075909" y="3076672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4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39AD32CD-D0B0-3AA3-5B7F-4A33021A6C54}"/>
                  </a:ext>
                </a:extLst>
              </p:cNvPr>
              <p:cNvSpPr txBox="1"/>
              <p:nvPr/>
            </p:nvSpPr>
            <p:spPr>
              <a:xfrm>
                <a:off x="2075909" y="2817038"/>
                <a:ext cx="1691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ACDE51C1-0F93-8CEC-2D6B-2F88EB8005CB}"/>
                </a:ext>
              </a:extLst>
            </p:cNvPr>
            <p:cNvGrpSpPr/>
            <p:nvPr/>
          </p:nvGrpSpPr>
          <p:grpSpPr>
            <a:xfrm>
              <a:off x="794604" y="499183"/>
              <a:ext cx="2802783" cy="1786222"/>
              <a:chOff x="-2839216" y="2611186"/>
              <a:chExt cx="2598548" cy="1656063"/>
            </a:xfrm>
          </p:grpSpPr>
          <p:grpSp>
            <p:nvGrpSpPr>
              <p:cNvPr id="21" name="组合 20">
                <a:extLst>
                  <a:ext uri="{FF2B5EF4-FFF2-40B4-BE49-F238E27FC236}">
                    <a16:creationId xmlns:a16="http://schemas.microsoft.com/office/drawing/2014/main" id="{96681FF0-FE65-59F2-9349-9C55B25D9687}"/>
                  </a:ext>
                </a:extLst>
              </p:cNvPr>
              <p:cNvGrpSpPr/>
              <p:nvPr/>
            </p:nvGrpSpPr>
            <p:grpSpPr>
              <a:xfrm>
                <a:off x="-2839216" y="2816183"/>
                <a:ext cx="2536883" cy="1451066"/>
                <a:chOff x="-2839215" y="2816184"/>
                <a:chExt cx="2238052" cy="1280138"/>
              </a:xfrm>
            </p:grpSpPr>
            <p:pic>
              <p:nvPicPr>
                <p:cNvPr id="38" name="图片 37">
                  <a:extLst>
                    <a:ext uri="{FF2B5EF4-FFF2-40B4-BE49-F238E27FC236}">
                      <a16:creationId xmlns:a16="http://schemas.microsoft.com/office/drawing/2014/main" id="{3346E9D4-1B6B-5420-64AA-C9913735B6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" t="20377" r="-132"/>
                <a:stretch/>
              </p:blipFill>
              <p:spPr>
                <a:xfrm>
                  <a:off x="-2693651" y="2816184"/>
                  <a:ext cx="2092488" cy="1152000"/>
                </a:xfrm>
                <a:prstGeom prst="rect">
                  <a:avLst/>
                </a:prstGeom>
              </p:spPr>
            </p:pic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37714503-5A20-7195-1CBB-4BFCE9A22D4B}"/>
                    </a:ext>
                  </a:extLst>
                </p:cNvPr>
                <p:cNvSpPr txBox="1"/>
                <p:nvPr/>
              </p:nvSpPr>
              <p:spPr>
                <a:xfrm>
                  <a:off x="-2366608" y="3988600"/>
                  <a:ext cx="153826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0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F1AB08C8-40C3-EE28-680A-2EDCDB0AE542}"/>
                    </a:ext>
                  </a:extLst>
                </p:cNvPr>
                <p:cNvSpPr txBox="1"/>
                <p:nvPr/>
              </p:nvSpPr>
              <p:spPr>
                <a:xfrm>
                  <a:off x="-2078346" y="3986219"/>
                  <a:ext cx="240252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5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9B8730D0-74A0-0DE2-1C6C-AC7380CA79A8}"/>
                    </a:ext>
                  </a:extLst>
                </p:cNvPr>
                <p:cNvSpPr txBox="1"/>
                <p:nvPr/>
              </p:nvSpPr>
              <p:spPr>
                <a:xfrm>
                  <a:off x="-2713536" y="3988600"/>
                  <a:ext cx="178196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-5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A4B75F52-A884-7BD7-2BF7-4F99E94F322C}"/>
                    </a:ext>
                  </a:extLst>
                </p:cNvPr>
                <p:cNvSpPr txBox="1"/>
                <p:nvPr/>
              </p:nvSpPr>
              <p:spPr>
                <a:xfrm>
                  <a:off x="-1315901" y="3988600"/>
                  <a:ext cx="153826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0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97F25830-3BEC-660D-E34E-429B24E7B00C}"/>
                    </a:ext>
                  </a:extLst>
                </p:cNvPr>
                <p:cNvSpPr txBox="1"/>
                <p:nvPr/>
              </p:nvSpPr>
              <p:spPr>
                <a:xfrm>
                  <a:off x="-1024399" y="3988600"/>
                  <a:ext cx="240252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5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BAE8ACDE-2C9A-9C9D-79F9-35718F1D78F2}"/>
                    </a:ext>
                  </a:extLst>
                </p:cNvPr>
                <p:cNvSpPr txBox="1"/>
                <p:nvPr/>
              </p:nvSpPr>
              <p:spPr>
                <a:xfrm>
                  <a:off x="-1678597" y="3988600"/>
                  <a:ext cx="193663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-5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3C7125E3-281B-9421-BC0E-F9E431E0B354}"/>
                    </a:ext>
                  </a:extLst>
                </p:cNvPr>
                <p:cNvSpPr txBox="1"/>
                <p:nvPr/>
              </p:nvSpPr>
              <p:spPr>
                <a:xfrm>
                  <a:off x="-2839215" y="3876692"/>
                  <a:ext cx="1473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-4</a:t>
                  </a: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DDADC729-B452-99AF-8C44-EB3E3B8AFCCF}"/>
                    </a:ext>
                  </a:extLst>
                </p:cNvPr>
                <p:cNvSpPr txBox="1"/>
                <p:nvPr/>
              </p:nvSpPr>
              <p:spPr>
                <a:xfrm>
                  <a:off x="-2839215" y="3665382"/>
                  <a:ext cx="1473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-2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5A46D13D-68A9-AE0E-A99B-153A03EAEA47}"/>
                    </a:ext>
                  </a:extLst>
                </p:cNvPr>
                <p:cNvSpPr txBox="1"/>
                <p:nvPr/>
              </p:nvSpPr>
              <p:spPr>
                <a:xfrm>
                  <a:off x="-2839215" y="3454070"/>
                  <a:ext cx="1473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0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FDC683AE-2225-B755-482A-3422251C190E}"/>
                    </a:ext>
                  </a:extLst>
                </p:cNvPr>
                <p:cNvSpPr txBox="1"/>
                <p:nvPr/>
              </p:nvSpPr>
              <p:spPr>
                <a:xfrm>
                  <a:off x="-2839215" y="3242758"/>
                  <a:ext cx="1473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2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B7AB2B3C-0718-70D0-5E17-FBC121C783DA}"/>
                    </a:ext>
                  </a:extLst>
                </p:cNvPr>
                <p:cNvSpPr txBox="1"/>
                <p:nvPr/>
              </p:nvSpPr>
              <p:spPr>
                <a:xfrm>
                  <a:off x="-2839215" y="3031446"/>
                  <a:ext cx="1473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4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8D638BC0-1AF1-9D47-F065-D84C01549677}"/>
                    </a:ext>
                  </a:extLst>
                </p:cNvPr>
                <p:cNvSpPr txBox="1"/>
                <p:nvPr/>
              </p:nvSpPr>
              <p:spPr>
                <a:xfrm>
                  <a:off x="-2839215" y="2820134"/>
                  <a:ext cx="1473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6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" name="任意多边形: 形状 21">
                <a:extLst>
                  <a:ext uri="{FF2B5EF4-FFF2-40B4-BE49-F238E27FC236}">
                    <a16:creationId xmlns:a16="http://schemas.microsoft.com/office/drawing/2014/main" id="{77D0097B-91DA-8CD7-3BE4-402DEEF5794F}"/>
                  </a:ext>
                </a:extLst>
              </p:cNvPr>
              <p:cNvSpPr/>
              <p:nvPr/>
            </p:nvSpPr>
            <p:spPr>
              <a:xfrm>
                <a:off x="-2447929" y="3048261"/>
                <a:ext cx="795711" cy="596363"/>
              </a:xfrm>
              <a:custGeom>
                <a:avLst/>
                <a:gdLst>
                  <a:gd name="connsiteX0" fmla="*/ 69287 w 892247"/>
                  <a:gd name="connsiteY0" fmla="*/ 0 h 767819"/>
                  <a:gd name="connsiteX1" fmla="*/ 707 w 892247"/>
                  <a:gd name="connsiteY1" fmla="*/ 373380 h 767819"/>
                  <a:gd name="connsiteX2" fmla="*/ 107387 w 892247"/>
                  <a:gd name="connsiteY2" fmla="*/ 746760 h 767819"/>
                  <a:gd name="connsiteX3" fmla="*/ 442667 w 892247"/>
                  <a:gd name="connsiteY3" fmla="*/ 701040 h 767819"/>
                  <a:gd name="connsiteX4" fmla="*/ 663647 w 892247"/>
                  <a:gd name="connsiteY4" fmla="*/ 533400 h 767819"/>
                  <a:gd name="connsiteX5" fmla="*/ 892247 w 892247"/>
                  <a:gd name="connsiteY5" fmla="*/ 441960 h 767819"/>
                  <a:gd name="connsiteX0" fmla="*/ 69287 w 892247"/>
                  <a:gd name="connsiteY0" fmla="*/ 0 h 767819"/>
                  <a:gd name="connsiteX1" fmla="*/ 707 w 892247"/>
                  <a:gd name="connsiteY1" fmla="*/ 373380 h 767819"/>
                  <a:gd name="connsiteX2" fmla="*/ 107387 w 892247"/>
                  <a:gd name="connsiteY2" fmla="*/ 746760 h 767819"/>
                  <a:gd name="connsiteX3" fmla="*/ 442667 w 892247"/>
                  <a:gd name="connsiteY3" fmla="*/ 701040 h 767819"/>
                  <a:gd name="connsiteX4" fmla="*/ 663647 w 892247"/>
                  <a:gd name="connsiteY4" fmla="*/ 533400 h 767819"/>
                  <a:gd name="connsiteX5" fmla="*/ 892247 w 892247"/>
                  <a:gd name="connsiteY5" fmla="*/ 441960 h 7678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892247" h="767819">
                    <a:moveTo>
                      <a:pt x="69287" y="0"/>
                    </a:moveTo>
                    <a:cubicBezTo>
                      <a:pt x="31822" y="124460"/>
                      <a:pt x="-5643" y="248920"/>
                      <a:pt x="707" y="373380"/>
                    </a:cubicBezTo>
                    <a:cubicBezTo>
                      <a:pt x="7057" y="497840"/>
                      <a:pt x="33727" y="692150"/>
                      <a:pt x="107387" y="746760"/>
                    </a:cubicBezTo>
                    <a:cubicBezTo>
                      <a:pt x="181047" y="801370"/>
                      <a:pt x="349957" y="736600"/>
                      <a:pt x="442667" y="701040"/>
                    </a:cubicBezTo>
                    <a:cubicBezTo>
                      <a:pt x="535377" y="665480"/>
                      <a:pt x="588717" y="576580"/>
                      <a:pt x="663647" y="533400"/>
                    </a:cubicBezTo>
                    <a:cubicBezTo>
                      <a:pt x="738577" y="490220"/>
                      <a:pt x="815412" y="466090"/>
                      <a:pt x="892247" y="441960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  <a:prstDash val="dash"/>
                <a:headEnd type="diamond" w="sm" len="sm"/>
                <a:tailEnd type="stealth" w="sm" len="sm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3" name="任意多边形: 形状 22">
                <a:extLst>
                  <a:ext uri="{FF2B5EF4-FFF2-40B4-BE49-F238E27FC236}">
                    <a16:creationId xmlns:a16="http://schemas.microsoft.com/office/drawing/2014/main" id="{8022754D-C828-480E-9395-446AC2498B3E}"/>
                  </a:ext>
                </a:extLst>
              </p:cNvPr>
              <p:cNvSpPr/>
              <p:nvPr/>
            </p:nvSpPr>
            <p:spPr>
              <a:xfrm>
                <a:off x="-1258795" y="3048261"/>
                <a:ext cx="795711" cy="596363"/>
              </a:xfrm>
              <a:custGeom>
                <a:avLst/>
                <a:gdLst>
                  <a:gd name="connsiteX0" fmla="*/ 69287 w 892247"/>
                  <a:gd name="connsiteY0" fmla="*/ 0 h 767819"/>
                  <a:gd name="connsiteX1" fmla="*/ 707 w 892247"/>
                  <a:gd name="connsiteY1" fmla="*/ 373380 h 767819"/>
                  <a:gd name="connsiteX2" fmla="*/ 107387 w 892247"/>
                  <a:gd name="connsiteY2" fmla="*/ 746760 h 767819"/>
                  <a:gd name="connsiteX3" fmla="*/ 442667 w 892247"/>
                  <a:gd name="connsiteY3" fmla="*/ 701040 h 767819"/>
                  <a:gd name="connsiteX4" fmla="*/ 663647 w 892247"/>
                  <a:gd name="connsiteY4" fmla="*/ 533400 h 767819"/>
                  <a:gd name="connsiteX5" fmla="*/ 892247 w 892247"/>
                  <a:gd name="connsiteY5" fmla="*/ 441960 h 767819"/>
                  <a:gd name="connsiteX0" fmla="*/ 69287 w 892247"/>
                  <a:gd name="connsiteY0" fmla="*/ 0 h 767819"/>
                  <a:gd name="connsiteX1" fmla="*/ 707 w 892247"/>
                  <a:gd name="connsiteY1" fmla="*/ 373380 h 767819"/>
                  <a:gd name="connsiteX2" fmla="*/ 107387 w 892247"/>
                  <a:gd name="connsiteY2" fmla="*/ 746760 h 767819"/>
                  <a:gd name="connsiteX3" fmla="*/ 442667 w 892247"/>
                  <a:gd name="connsiteY3" fmla="*/ 701040 h 767819"/>
                  <a:gd name="connsiteX4" fmla="*/ 663647 w 892247"/>
                  <a:gd name="connsiteY4" fmla="*/ 533400 h 767819"/>
                  <a:gd name="connsiteX5" fmla="*/ 892247 w 892247"/>
                  <a:gd name="connsiteY5" fmla="*/ 441960 h 7678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892247" h="767819">
                    <a:moveTo>
                      <a:pt x="69287" y="0"/>
                    </a:moveTo>
                    <a:cubicBezTo>
                      <a:pt x="31822" y="124460"/>
                      <a:pt x="-5643" y="248920"/>
                      <a:pt x="707" y="373380"/>
                    </a:cubicBezTo>
                    <a:cubicBezTo>
                      <a:pt x="7057" y="497840"/>
                      <a:pt x="33727" y="692150"/>
                      <a:pt x="107387" y="746760"/>
                    </a:cubicBezTo>
                    <a:cubicBezTo>
                      <a:pt x="181047" y="801370"/>
                      <a:pt x="349957" y="736600"/>
                      <a:pt x="442667" y="701040"/>
                    </a:cubicBezTo>
                    <a:cubicBezTo>
                      <a:pt x="535377" y="665480"/>
                      <a:pt x="588717" y="576580"/>
                      <a:pt x="663647" y="533400"/>
                    </a:cubicBezTo>
                    <a:cubicBezTo>
                      <a:pt x="738577" y="490220"/>
                      <a:pt x="815412" y="466090"/>
                      <a:pt x="892247" y="441960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  <a:prstDash val="dash"/>
                <a:headEnd type="diamond" w="sm" len="sm"/>
                <a:tailEnd type="stealth" w="sm" len="sm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29BCD768-86C2-D7C7-0DBD-C1198097B53F}"/>
                  </a:ext>
                </a:extLst>
              </p:cNvPr>
              <p:cNvSpPr txBox="1"/>
              <p:nvPr/>
            </p:nvSpPr>
            <p:spPr>
              <a:xfrm>
                <a:off x="-2272183" y="2811424"/>
                <a:ext cx="332656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OVA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7E7B45CD-8998-234E-2F5B-391E4EB2CD54}"/>
                  </a:ext>
                </a:extLst>
              </p:cNvPr>
              <p:cNvSpPr txBox="1"/>
              <p:nvPr/>
            </p:nvSpPr>
            <p:spPr>
              <a:xfrm>
                <a:off x="-1014382" y="2809195"/>
                <a:ext cx="228322" cy="10766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PBS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BF480C7B-19A4-E8AA-1C96-3D287073657F}"/>
                  </a:ext>
                </a:extLst>
              </p:cNvPr>
              <p:cNvGrpSpPr/>
              <p:nvPr/>
            </p:nvGrpSpPr>
            <p:grpSpPr>
              <a:xfrm>
                <a:off x="-2086196" y="2611186"/>
                <a:ext cx="732474" cy="107722"/>
                <a:chOff x="7837171" y="969234"/>
                <a:chExt cx="732474" cy="107722"/>
              </a:xfrm>
            </p:grpSpPr>
            <p:sp>
              <p:nvSpPr>
                <p:cNvPr id="36" name="椭圆 35">
                  <a:extLst>
                    <a:ext uri="{FF2B5EF4-FFF2-40B4-BE49-F238E27FC236}">
                      <a16:creationId xmlns:a16="http://schemas.microsoft.com/office/drawing/2014/main" id="{4BB06A83-1693-C0BE-F661-7803D7CE4A8B}"/>
                    </a:ext>
                  </a:extLst>
                </p:cNvPr>
                <p:cNvSpPr/>
                <p:nvPr/>
              </p:nvSpPr>
              <p:spPr>
                <a:xfrm>
                  <a:off x="7837171" y="996095"/>
                  <a:ext cx="54000" cy="54000"/>
                </a:xfrm>
                <a:prstGeom prst="ellipse">
                  <a:avLst/>
                </a:prstGeom>
                <a:solidFill>
                  <a:srgbClr val="F9766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  <p:sp>
              <p:nvSpPr>
                <p:cNvPr id="37" name="文本框 36">
                  <a:extLst>
                    <a:ext uri="{FF2B5EF4-FFF2-40B4-BE49-F238E27FC236}">
                      <a16:creationId xmlns:a16="http://schemas.microsoft.com/office/drawing/2014/main" id="{9CEE749F-AF37-7586-7D97-CF42663D2100}"/>
                    </a:ext>
                  </a:extLst>
                </p:cNvPr>
                <p:cNvSpPr txBox="1"/>
                <p:nvPr/>
              </p:nvSpPr>
              <p:spPr>
                <a:xfrm>
                  <a:off x="7907779" y="969234"/>
                  <a:ext cx="661866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Apoptotic club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B743E379-EF6A-C6EF-8C73-438D150DB7C6}"/>
                  </a:ext>
                </a:extLst>
              </p:cNvPr>
              <p:cNvGrpSpPr/>
              <p:nvPr/>
            </p:nvGrpSpPr>
            <p:grpSpPr>
              <a:xfrm>
                <a:off x="-2785117" y="2611186"/>
                <a:ext cx="698365" cy="107722"/>
                <a:chOff x="7837171" y="754246"/>
                <a:chExt cx="698365" cy="107722"/>
              </a:xfrm>
            </p:grpSpPr>
            <p:sp>
              <p:nvSpPr>
                <p:cNvPr id="34" name="椭圆 33">
                  <a:extLst>
                    <a:ext uri="{FF2B5EF4-FFF2-40B4-BE49-F238E27FC236}">
                      <a16:creationId xmlns:a16="http://schemas.microsoft.com/office/drawing/2014/main" id="{6753B02B-64D0-1AEF-2592-A9071D89C37B}"/>
                    </a:ext>
                  </a:extLst>
                </p:cNvPr>
                <p:cNvSpPr/>
                <p:nvPr/>
              </p:nvSpPr>
              <p:spPr>
                <a:xfrm>
                  <a:off x="7837171" y="781107"/>
                  <a:ext cx="54000" cy="54000"/>
                </a:xfrm>
                <a:prstGeom prst="ellipse">
                  <a:avLst/>
                </a:prstGeom>
                <a:solidFill>
                  <a:srgbClr val="C77C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63A9B423-3C60-9C6C-E850-D9F7EBDFD286}"/>
                    </a:ext>
                  </a:extLst>
                </p:cNvPr>
                <p:cNvSpPr txBox="1"/>
                <p:nvPr/>
              </p:nvSpPr>
              <p:spPr>
                <a:xfrm>
                  <a:off x="7907779" y="754246"/>
                  <a:ext cx="627757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Quiescent club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51024551-9482-7B89-9C81-D147A54D14A8}"/>
                  </a:ext>
                </a:extLst>
              </p:cNvPr>
              <p:cNvGrpSpPr/>
              <p:nvPr/>
            </p:nvGrpSpPr>
            <p:grpSpPr>
              <a:xfrm>
                <a:off x="-1419206" y="2611186"/>
                <a:ext cx="732474" cy="107722"/>
                <a:chOff x="7837171" y="1080700"/>
                <a:chExt cx="732474" cy="107722"/>
              </a:xfrm>
            </p:grpSpPr>
            <p:sp>
              <p:nvSpPr>
                <p:cNvPr id="32" name="椭圆 31">
                  <a:extLst>
                    <a:ext uri="{FF2B5EF4-FFF2-40B4-BE49-F238E27FC236}">
                      <a16:creationId xmlns:a16="http://schemas.microsoft.com/office/drawing/2014/main" id="{73A97551-95E8-BCB1-164C-93C3C9FB56E0}"/>
                    </a:ext>
                  </a:extLst>
                </p:cNvPr>
                <p:cNvSpPr/>
                <p:nvPr/>
              </p:nvSpPr>
              <p:spPr>
                <a:xfrm>
                  <a:off x="7837171" y="1107561"/>
                  <a:ext cx="54000" cy="54000"/>
                </a:xfrm>
                <a:prstGeom prst="ellipse">
                  <a:avLst/>
                </a:prstGeom>
                <a:solidFill>
                  <a:srgbClr val="00BFC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70FCB606-4C36-8790-3AC8-E2EDF6FD6F24}"/>
                    </a:ext>
                  </a:extLst>
                </p:cNvPr>
                <p:cNvSpPr txBox="1"/>
                <p:nvPr/>
              </p:nvSpPr>
              <p:spPr>
                <a:xfrm>
                  <a:off x="7907779" y="1080700"/>
                  <a:ext cx="661866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Proliferative club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组合 28">
                <a:extLst>
                  <a:ext uri="{FF2B5EF4-FFF2-40B4-BE49-F238E27FC236}">
                    <a16:creationId xmlns:a16="http://schemas.microsoft.com/office/drawing/2014/main" id="{660E3F3B-F985-BB52-3FDE-07C2EB219815}"/>
                  </a:ext>
                </a:extLst>
              </p:cNvPr>
              <p:cNvGrpSpPr/>
              <p:nvPr/>
            </p:nvGrpSpPr>
            <p:grpSpPr>
              <a:xfrm>
                <a:off x="-635377" y="2611186"/>
                <a:ext cx="394709" cy="107722"/>
                <a:chOff x="7837171" y="1189517"/>
                <a:chExt cx="394709" cy="107722"/>
              </a:xfrm>
            </p:grpSpPr>
            <p:sp>
              <p:nvSpPr>
                <p:cNvPr id="30" name="椭圆 29">
                  <a:extLst>
                    <a:ext uri="{FF2B5EF4-FFF2-40B4-BE49-F238E27FC236}">
                      <a16:creationId xmlns:a16="http://schemas.microsoft.com/office/drawing/2014/main" id="{66B8C0A9-CBCC-A41D-A08C-E3EB5B3C85AF}"/>
                    </a:ext>
                  </a:extLst>
                </p:cNvPr>
                <p:cNvSpPr/>
                <p:nvPr/>
              </p:nvSpPr>
              <p:spPr>
                <a:xfrm>
                  <a:off x="7837171" y="1216378"/>
                  <a:ext cx="54000" cy="54000"/>
                </a:xfrm>
                <a:prstGeom prst="ellipse">
                  <a:avLst/>
                </a:prstGeom>
                <a:solidFill>
                  <a:srgbClr val="00B72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/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EFDB7C20-CF41-7274-7FBB-D6AFB8A60430}"/>
                    </a:ext>
                  </a:extLst>
                </p:cNvPr>
                <p:cNvSpPr txBox="1"/>
                <p:nvPr/>
              </p:nvSpPr>
              <p:spPr>
                <a:xfrm>
                  <a:off x="7907779" y="1189517"/>
                  <a:ext cx="32410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defTabSz="457200"/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Goblet</a:t>
                  </a:r>
                  <a:endParaRPr lang="zh-CN" altLang="en-US" sz="7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26D507CE-B002-32B3-708B-61D4BDF19814}"/>
                </a:ext>
              </a:extLst>
            </p:cNvPr>
            <p:cNvGrpSpPr/>
            <p:nvPr/>
          </p:nvGrpSpPr>
          <p:grpSpPr>
            <a:xfrm>
              <a:off x="756936" y="2686491"/>
              <a:ext cx="1409052" cy="1382296"/>
              <a:chOff x="5188478" y="3238682"/>
              <a:chExt cx="1548000" cy="1518605"/>
            </a:xfrm>
          </p:grpSpPr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5CD5B040-D566-57ED-0B5C-04949986AACB}"/>
                  </a:ext>
                </a:extLst>
              </p:cNvPr>
              <p:cNvSpPr txBox="1"/>
              <p:nvPr/>
            </p:nvSpPr>
            <p:spPr>
              <a:xfrm rot="16200000">
                <a:off x="4828991" y="3680433"/>
                <a:ext cx="86400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algn="r">
                  <a:defRPr sz="10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ctr"/>
                <a:r>
                  <a:rPr lang="en-US" altLang="zh-CN" sz="700" dirty="0"/>
                  <a:t>% of airway cells</a:t>
                </a:r>
              </a:p>
            </p:txBody>
          </p:sp>
          <p:graphicFrame>
            <p:nvGraphicFramePr>
              <p:cNvPr id="53" name="图表 52">
                <a:extLst>
                  <a:ext uri="{FF2B5EF4-FFF2-40B4-BE49-F238E27FC236}">
                    <a16:creationId xmlns:a16="http://schemas.microsoft.com/office/drawing/2014/main" id="{8AC63E04-1C1E-4166-25FC-1847A9E722E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3189177"/>
                  </p:ext>
                </p:extLst>
              </p:nvPr>
            </p:nvGraphicFramePr>
            <p:xfrm>
              <a:off x="5188478" y="3245287"/>
              <a:ext cx="1548000" cy="151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54" name="组合 53">
                <a:extLst>
                  <a:ext uri="{FF2B5EF4-FFF2-40B4-BE49-F238E27FC236}">
                    <a16:creationId xmlns:a16="http://schemas.microsoft.com/office/drawing/2014/main" id="{66DFD3CA-412D-DB7B-7BEB-CD4C0F01C79D}"/>
                  </a:ext>
                </a:extLst>
              </p:cNvPr>
              <p:cNvGrpSpPr/>
              <p:nvPr/>
            </p:nvGrpSpPr>
            <p:grpSpPr>
              <a:xfrm>
                <a:off x="5489468" y="3238682"/>
                <a:ext cx="739385" cy="107722"/>
                <a:chOff x="4699543" y="5364084"/>
                <a:chExt cx="739385" cy="107722"/>
              </a:xfrm>
            </p:grpSpPr>
            <p:grpSp>
              <p:nvGrpSpPr>
                <p:cNvPr id="55" name="组合 54">
                  <a:extLst>
                    <a:ext uri="{FF2B5EF4-FFF2-40B4-BE49-F238E27FC236}">
                      <a16:creationId xmlns:a16="http://schemas.microsoft.com/office/drawing/2014/main" id="{36357692-B799-26D9-FA17-D9ECBB44C5A4}"/>
                    </a:ext>
                  </a:extLst>
                </p:cNvPr>
                <p:cNvGrpSpPr/>
                <p:nvPr/>
              </p:nvGrpSpPr>
              <p:grpSpPr>
                <a:xfrm>
                  <a:off x="4699543" y="5364084"/>
                  <a:ext cx="326761" cy="107722"/>
                  <a:chOff x="3428725" y="4874191"/>
                  <a:chExt cx="326761" cy="107722"/>
                </a:xfrm>
              </p:grpSpPr>
              <p:sp>
                <p:nvSpPr>
                  <p:cNvPr id="59" name="文本框 58">
                    <a:extLst>
                      <a:ext uri="{FF2B5EF4-FFF2-40B4-BE49-F238E27FC236}">
                        <a16:creationId xmlns:a16="http://schemas.microsoft.com/office/drawing/2014/main" id="{D0F14C67-6BD9-C4A2-107E-99D7FC86184E}"/>
                      </a:ext>
                    </a:extLst>
                  </p:cNvPr>
                  <p:cNvSpPr txBox="1"/>
                  <p:nvPr/>
                </p:nvSpPr>
                <p:spPr>
                  <a:xfrm>
                    <a:off x="3486787" y="4874191"/>
                    <a:ext cx="268699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>
                    <a:defPPr>
                      <a:defRPr lang="zh-CN"/>
                    </a:defPPr>
                    <a:lvl1pPr algn="r">
                      <a:defRPr sz="10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pPr algn="ctr"/>
                    <a:r>
                      <a:rPr lang="en-US" altLang="zh-CN" sz="700" dirty="0"/>
                      <a:t>PBS</a:t>
                    </a:r>
                  </a:p>
                </p:txBody>
              </p:sp>
              <p:sp>
                <p:nvSpPr>
                  <p:cNvPr id="60" name="矩形 59">
                    <a:extLst>
                      <a:ext uri="{FF2B5EF4-FFF2-40B4-BE49-F238E27FC236}">
                        <a16:creationId xmlns:a16="http://schemas.microsoft.com/office/drawing/2014/main" id="{723F1C1E-5492-1DEF-1856-DBA2441BA515}"/>
                      </a:ext>
                    </a:extLst>
                  </p:cNvPr>
                  <p:cNvSpPr/>
                  <p:nvPr/>
                </p:nvSpPr>
                <p:spPr>
                  <a:xfrm>
                    <a:off x="3428725" y="4886036"/>
                    <a:ext cx="72000" cy="72000"/>
                  </a:xfrm>
                  <a:prstGeom prst="rect">
                    <a:avLst/>
                  </a:prstGeom>
                  <a:solidFill>
                    <a:srgbClr val="D3B265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/>
                  </a:p>
                </p:txBody>
              </p:sp>
            </p:grpSp>
            <p:grpSp>
              <p:nvGrpSpPr>
                <p:cNvPr id="56" name="组合 55">
                  <a:extLst>
                    <a:ext uri="{FF2B5EF4-FFF2-40B4-BE49-F238E27FC236}">
                      <a16:creationId xmlns:a16="http://schemas.microsoft.com/office/drawing/2014/main" id="{3096A2DC-CB6F-712C-D7A2-E4844465A69E}"/>
                    </a:ext>
                  </a:extLst>
                </p:cNvPr>
                <p:cNvGrpSpPr/>
                <p:nvPr/>
              </p:nvGrpSpPr>
              <p:grpSpPr>
                <a:xfrm>
                  <a:off x="5112167" y="5364084"/>
                  <a:ext cx="326761" cy="107722"/>
                  <a:chOff x="3428725" y="5014526"/>
                  <a:chExt cx="326761" cy="107722"/>
                </a:xfrm>
              </p:grpSpPr>
              <p:sp>
                <p:nvSpPr>
                  <p:cNvPr id="57" name="文本框 56">
                    <a:extLst>
                      <a:ext uri="{FF2B5EF4-FFF2-40B4-BE49-F238E27FC236}">
                        <a16:creationId xmlns:a16="http://schemas.microsoft.com/office/drawing/2014/main" id="{D1E0AB80-7954-7B82-9F67-CD1F79460C25}"/>
                      </a:ext>
                    </a:extLst>
                  </p:cNvPr>
                  <p:cNvSpPr txBox="1"/>
                  <p:nvPr/>
                </p:nvSpPr>
                <p:spPr>
                  <a:xfrm>
                    <a:off x="3486787" y="5014526"/>
                    <a:ext cx="268699" cy="107722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>
                    <a:defPPr>
                      <a:defRPr lang="zh-CN"/>
                    </a:defPPr>
                    <a:lvl1pPr algn="r">
                      <a:defRPr sz="10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pPr algn="ctr"/>
                    <a:r>
                      <a:rPr lang="en-US" altLang="zh-CN" sz="700" dirty="0"/>
                      <a:t>OVA</a:t>
                    </a:r>
                  </a:p>
                </p:txBody>
              </p:sp>
              <p:sp>
                <p:nvSpPr>
                  <p:cNvPr id="58" name="矩形 57">
                    <a:extLst>
                      <a:ext uri="{FF2B5EF4-FFF2-40B4-BE49-F238E27FC236}">
                        <a16:creationId xmlns:a16="http://schemas.microsoft.com/office/drawing/2014/main" id="{8269608D-F228-3FD7-F500-EC6082BFA366}"/>
                      </a:ext>
                    </a:extLst>
                  </p:cNvPr>
                  <p:cNvSpPr/>
                  <p:nvPr/>
                </p:nvSpPr>
                <p:spPr>
                  <a:xfrm>
                    <a:off x="3428725" y="5025410"/>
                    <a:ext cx="72000" cy="72000"/>
                  </a:xfrm>
                  <a:prstGeom prst="rect">
                    <a:avLst/>
                  </a:prstGeom>
                  <a:solidFill>
                    <a:srgbClr val="082E5A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/>
                  </a:p>
                </p:txBody>
              </p:sp>
            </p:grpSp>
          </p:grpSp>
        </p:grpSp>
        <p:grpSp>
          <p:nvGrpSpPr>
            <p:cNvPr id="61" name="组合 60">
              <a:extLst>
                <a:ext uri="{FF2B5EF4-FFF2-40B4-BE49-F238E27FC236}">
                  <a16:creationId xmlns:a16="http://schemas.microsoft.com/office/drawing/2014/main" id="{6BD227D8-CE60-EA53-5502-477EBFE263A9}"/>
                </a:ext>
              </a:extLst>
            </p:cNvPr>
            <p:cNvGrpSpPr/>
            <p:nvPr/>
          </p:nvGrpSpPr>
          <p:grpSpPr>
            <a:xfrm>
              <a:off x="2177343" y="2552983"/>
              <a:ext cx="1617048" cy="1270385"/>
              <a:chOff x="4214683" y="2568016"/>
              <a:chExt cx="1869642" cy="1399899"/>
            </a:xfrm>
          </p:grpSpPr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365BB469-758B-0B69-7DBA-FF287206FDC1}"/>
                  </a:ext>
                </a:extLst>
              </p:cNvPr>
              <p:cNvSpPr txBox="1"/>
              <p:nvPr/>
            </p:nvSpPr>
            <p:spPr>
              <a:xfrm rot="16200000">
                <a:off x="3933880" y="2987628"/>
                <a:ext cx="855791" cy="29418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expressio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0F76F7E7-6B00-CC6C-54B9-14B1A62570E0}"/>
                  </a:ext>
                </a:extLst>
              </p:cNvPr>
              <p:cNvSpPr txBox="1"/>
              <p:nvPr/>
            </p:nvSpPr>
            <p:spPr>
              <a:xfrm>
                <a:off x="4411332" y="3527338"/>
                <a:ext cx="112113" cy="9736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ABA9DC3D-5F5B-BA51-4AB7-571ECF423540}"/>
                  </a:ext>
                </a:extLst>
              </p:cNvPr>
              <p:cNvSpPr txBox="1"/>
              <p:nvPr/>
            </p:nvSpPr>
            <p:spPr>
              <a:xfrm>
                <a:off x="4411332" y="3206393"/>
                <a:ext cx="112113" cy="9736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B0011F8A-9CF2-0714-7A77-E10EC7EDF8B0}"/>
                  </a:ext>
                </a:extLst>
              </p:cNvPr>
              <p:cNvSpPr txBox="1"/>
              <p:nvPr/>
            </p:nvSpPr>
            <p:spPr>
              <a:xfrm>
                <a:off x="4411332" y="2900043"/>
                <a:ext cx="112113" cy="9736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6F8263B9-33D0-DBAA-5A12-3680269E2BD9}"/>
                  </a:ext>
                </a:extLst>
              </p:cNvPr>
              <p:cNvSpPr txBox="1"/>
              <p:nvPr/>
            </p:nvSpPr>
            <p:spPr>
              <a:xfrm>
                <a:off x="4411332" y="2583802"/>
                <a:ext cx="112113" cy="9736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473E2BAE-D34F-52EE-2827-6678FBC4DBAE}"/>
                  </a:ext>
                </a:extLst>
              </p:cNvPr>
              <p:cNvSpPr txBox="1"/>
              <p:nvPr/>
            </p:nvSpPr>
            <p:spPr>
              <a:xfrm rot="19413120">
                <a:off x="4468243" y="3761140"/>
                <a:ext cx="440740" cy="17092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poptotic </a:t>
                </a:r>
              </a:p>
              <a:p>
                <a:pPr algn="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lu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99ED27AC-4B94-03B9-52F4-5D13D94D53C9}"/>
                  </a:ext>
                </a:extLst>
              </p:cNvPr>
              <p:cNvSpPr txBox="1"/>
              <p:nvPr/>
            </p:nvSpPr>
            <p:spPr>
              <a:xfrm rot="19413120">
                <a:off x="4821363" y="3796995"/>
                <a:ext cx="597053" cy="17092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roliferative </a:t>
                </a:r>
              </a:p>
              <a:p>
                <a:pPr algn="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lu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47FFAED3-3790-7417-F25F-3DF485E7ED3E}"/>
                  </a:ext>
                </a:extLst>
              </p:cNvPr>
              <p:cNvSpPr txBox="1"/>
              <p:nvPr/>
            </p:nvSpPr>
            <p:spPr>
              <a:xfrm rot="19413120">
                <a:off x="5398157" y="3775103"/>
                <a:ext cx="490072" cy="17092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Quiescent </a:t>
                </a:r>
              </a:p>
              <a:p>
                <a:pPr algn="r">
                  <a:lnSpc>
                    <a:spcPts val="6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lu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0" name="图片 69">
                <a:extLst>
                  <a:ext uri="{FF2B5EF4-FFF2-40B4-BE49-F238E27FC236}">
                    <a16:creationId xmlns:a16="http://schemas.microsoft.com/office/drawing/2014/main" id="{9B26A842-5671-5FDA-1C70-F2241782D33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64" t="8740" r="26434" b="27926"/>
              <a:stretch/>
            </p:blipFill>
            <p:spPr>
              <a:xfrm>
                <a:off x="4513367" y="2568016"/>
                <a:ext cx="1570958" cy="1080000"/>
              </a:xfrm>
              <a:prstGeom prst="rect">
                <a:avLst/>
              </a:prstGeom>
            </p:spPr>
          </p:pic>
        </p:grp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DA78A336-D3A4-104F-B596-9ADEFFF673A9}"/>
                </a:ext>
              </a:extLst>
            </p:cNvPr>
            <p:cNvGrpSpPr/>
            <p:nvPr/>
          </p:nvGrpSpPr>
          <p:grpSpPr>
            <a:xfrm>
              <a:off x="3915795" y="2577070"/>
              <a:ext cx="1153924" cy="1129143"/>
              <a:chOff x="3502485" y="2282420"/>
              <a:chExt cx="1271564" cy="1244257"/>
            </a:xfrm>
          </p:grpSpPr>
          <p:pic>
            <p:nvPicPr>
              <p:cNvPr id="83" name="图片 82">
                <a:extLst>
                  <a:ext uri="{FF2B5EF4-FFF2-40B4-BE49-F238E27FC236}">
                    <a16:creationId xmlns:a16="http://schemas.microsoft.com/office/drawing/2014/main" id="{E56F4412-C7E3-48E8-48A6-CAB7102E6ED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861" t="9437" r="16949" b="15594"/>
              <a:stretch/>
            </p:blipFill>
            <p:spPr>
              <a:xfrm>
                <a:off x="3806414" y="2473087"/>
                <a:ext cx="940489" cy="936000"/>
              </a:xfrm>
              <a:prstGeom prst="rect">
                <a:avLst/>
              </a:prstGeom>
            </p:spPr>
          </p:pic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6C3A497F-51F0-975D-016F-1BBA9D82A3F1}"/>
                  </a:ext>
                </a:extLst>
              </p:cNvPr>
              <p:cNvSpPr txBox="1"/>
              <p:nvPr/>
            </p:nvSpPr>
            <p:spPr>
              <a:xfrm>
                <a:off x="4343309" y="3418951"/>
                <a:ext cx="30059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2BC7C142-1E1E-6146-1C8F-BA545A94C5DE}"/>
                  </a:ext>
                </a:extLst>
              </p:cNvPr>
              <p:cNvSpPr txBox="1"/>
              <p:nvPr/>
            </p:nvSpPr>
            <p:spPr>
              <a:xfrm>
                <a:off x="3917290" y="3418955"/>
                <a:ext cx="30059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V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717C830F-83B6-6C06-36DC-48FDEB974B3C}"/>
                  </a:ext>
                </a:extLst>
              </p:cNvPr>
              <p:cNvSpPr txBox="1"/>
              <p:nvPr/>
            </p:nvSpPr>
            <p:spPr>
              <a:xfrm>
                <a:off x="3975605" y="2282420"/>
                <a:ext cx="62626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poptotic club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FE393728-ABF5-CD7C-DA9A-4E937C38A96D}"/>
                  </a:ext>
                </a:extLst>
              </p:cNvPr>
              <p:cNvSpPr txBox="1"/>
              <p:nvPr/>
            </p:nvSpPr>
            <p:spPr>
              <a:xfrm>
                <a:off x="3597062" y="3288665"/>
                <a:ext cx="202834" cy="11870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DE0A2B17-398C-32CD-3A2B-FDDAC46DD895}"/>
                  </a:ext>
                </a:extLst>
              </p:cNvPr>
              <p:cNvSpPr txBox="1"/>
              <p:nvPr/>
            </p:nvSpPr>
            <p:spPr>
              <a:xfrm>
                <a:off x="3597062" y="3105253"/>
                <a:ext cx="202834" cy="11870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EE6C4204-908C-F14D-9B3A-90339202C5C4}"/>
                  </a:ext>
                </a:extLst>
              </p:cNvPr>
              <p:cNvSpPr txBox="1"/>
              <p:nvPr/>
            </p:nvSpPr>
            <p:spPr>
              <a:xfrm>
                <a:off x="3597062" y="2909149"/>
                <a:ext cx="202834" cy="11870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470B8C57-3250-9EC0-45C2-4EB06FE2DBD6}"/>
                  </a:ext>
                </a:extLst>
              </p:cNvPr>
              <p:cNvSpPr txBox="1"/>
              <p:nvPr/>
            </p:nvSpPr>
            <p:spPr>
              <a:xfrm>
                <a:off x="3597062" y="2727313"/>
                <a:ext cx="202834" cy="11870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5AEEBD8B-3F8C-8DEA-F54C-31AA74F04F21}"/>
                  </a:ext>
                </a:extLst>
              </p:cNvPr>
              <p:cNvSpPr txBox="1"/>
              <p:nvPr/>
            </p:nvSpPr>
            <p:spPr>
              <a:xfrm>
                <a:off x="3597062" y="2539500"/>
                <a:ext cx="202834" cy="11870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12DB6BD0-3452-3C0A-9F21-267FB658787F}"/>
                  </a:ext>
                </a:extLst>
              </p:cNvPr>
              <p:cNvSpPr txBox="1"/>
              <p:nvPr/>
            </p:nvSpPr>
            <p:spPr>
              <a:xfrm>
                <a:off x="4237155" y="2847007"/>
                <a:ext cx="536894" cy="769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28</a:t>
                </a:r>
                <a:endParaRPr lang="zh-CN" altLang="en-US" sz="5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FB43673D-E0DD-DD4A-3658-E396C19EDD19}"/>
                  </a:ext>
                </a:extLst>
              </p:cNvPr>
              <p:cNvSpPr txBox="1"/>
              <p:nvPr/>
            </p:nvSpPr>
            <p:spPr>
              <a:xfrm rot="16200000">
                <a:off x="3110056" y="2832076"/>
                <a:ext cx="903562" cy="11870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expressio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F433166C-429C-A16A-4140-DFE0D65E787F}"/>
                </a:ext>
              </a:extLst>
            </p:cNvPr>
            <p:cNvGrpSpPr/>
            <p:nvPr/>
          </p:nvGrpSpPr>
          <p:grpSpPr>
            <a:xfrm>
              <a:off x="5185752" y="2569149"/>
              <a:ext cx="1168204" cy="1144986"/>
              <a:chOff x="4906197" y="1606489"/>
              <a:chExt cx="1168204" cy="1144986"/>
            </a:xfrm>
          </p:grpSpPr>
          <p:grpSp>
            <p:nvGrpSpPr>
              <p:cNvPr id="71" name="组合 70">
                <a:extLst>
                  <a:ext uri="{FF2B5EF4-FFF2-40B4-BE49-F238E27FC236}">
                    <a16:creationId xmlns:a16="http://schemas.microsoft.com/office/drawing/2014/main" id="{EFC38152-94E5-33F7-0911-292233FACB43}"/>
                  </a:ext>
                </a:extLst>
              </p:cNvPr>
              <p:cNvGrpSpPr/>
              <p:nvPr/>
            </p:nvGrpSpPr>
            <p:grpSpPr>
              <a:xfrm>
                <a:off x="5032319" y="1606489"/>
                <a:ext cx="1042082" cy="1144986"/>
                <a:chOff x="4469791" y="6616125"/>
                <a:chExt cx="1042082" cy="1144986"/>
              </a:xfrm>
            </p:grpSpPr>
            <p:pic>
              <p:nvPicPr>
                <p:cNvPr id="72" name="图片 71">
                  <a:extLst>
                    <a:ext uri="{FF2B5EF4-FFF2-40B4-BE49-F238E27FC236}">
                      <a16:creationId xmlns:a16="http://schemas.microsoft.com/office/drawing/2014/main" id="{FD58400E-F63B-D6BE-BC51-E717F107D12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486" t="9073" r="17876" b="15656"/>
                <a:stretch/>
              </p:blipFill>
              <p:spPr>
                <a:xfrm>
                  <a:off x="4659864" y="6805150"/>
                  <a:ext cx="852009" cy="849405"/>
                </a:xfrm>
                <a:prstGeom prst="rect">
                  <a:avLst/>
                </a:prstGeom>
              </p:spPr>
            </p:pic>
            <p:sp>
              <p:nvSpPr>
                <p:cNvPr id="73" name="文本框 72">
                  <a:extLst>
                    <a:ext uri="{FF2B5EF4-FFF2-40B4-BE49-F238E27FC236}">
                      <a16:creationId xmlns:a16="http://schemas.microsoft.com/office/drawing/2014/main" id="{39099D74-0D65-1251-E1F3-8E5C68D35737}"/>
                    </a:ext>
                  </a:extLst>
                </p:cNvPr>
                <p:cNvSpPr txBox="1"/>
                <p:nvPr/>
              </p:nvSpPr>
              <p:spPr>
                <a:xfrm>
                  <a:off x="5149122" y="7663351"/>
                  <a:ext cx="272784" cy="97756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S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5CA9CF5D-646D-2682-1370-AC751B6608A0}"/>
                    </a:ext>
                  </a:extLst>
                </p:cNvPr>
                <p:cNvSpPr txBox="1"/>
                <p:nvPr/>
              </p:nvSpPr>
              <p:spPr>
                <a:xfrm>
                  <a:off x="4765974" y="7663355"/>
                  <a:ext cx="272784" cy="97756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A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文本框 74">
                  <a:extLst>
                    <a:ext uri="{FF2B5EF4-FFF2-40B4-BE49-F238E27FC236}">
                      <a16:creationId xmlns:a16="http://schemas.microsoft.com/office/drawing/2014/main" id="{C6F12CC3-D770-978A-709C-6E742C6D2E03}"/>
                    </a:ext>
                  </a:extLst>
                </p:cNvPr>
                <p:cNvSpPr txBox="1"/>
                <p:nvPr/>
              </p:nvSpPr>
              <p:spPr>
                <a:xfrm>
                  <a:off x="4671173" y="6616125"/>
                  <a:ext cx="832915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liferative club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文本框 75">
                  <a:extLst>
                    <a:ext uri="{FF2B5EF4-FFF2-40B4-BE49-F238E27FC236}">
                      <a16:creationId xmlns:a16="http://schemas.microsoft.com/office/drawing/2014/main" id="{D81BC3DA-CA62-79F9-C175-08A67904A2F2}"/>
                    </a:ext>
                  </a:extLst>
                </p:cNvPr>
                <p:cNvSpPr txBox="1"/>
                <p:nvPr/>
              </p:nvSpPr>
              <p:spPr>
                <a:xfrm>
                  <a:off x="4469791" y="7544223"/>
                  <a:ext cx="18406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文本框 76">
                  <a:extLst>
                    <a:ext uri="{FF2B5EF4-FFF2-40B4-BE49-F238E27FC236}">
                      <a16:creationId xmlns:a16="http://schemas.microsoft.com/office/drawing/2014/main" id="{88B5F90F-1A5E-6684-6A54-A349A303342F}"/>
                    </a:ext>
                  </a:extLst>
                </p:cNvPr>
                <p:cNvSpPr txBox="1"/>
                <p:nvPr/>
              </p:nvSpPr>
              <p:spPr>
                <a:xfrm>
                  <a:off x="4469791" y="7352809"/>
                  <a:ext cx="18406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C8D35308-8047-89BE-0CD9-5F9A79D1E729}"/>
                    </a:ext>
                  </a:extLst>
                </p:cNvPr>
                <p:cNvSpPr txBox="1"/>
                <p:nvPr/>
              </p:nvSpPr>
              <p:spPr>
                <a:xfrm>
                  <a:off x="4469791" y="7156431"/>
                  <a:ext cx="18406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文本框 78">
                  <a:extLst>
                    <a:ext uri="{FF2B5EF4-FFF2-40B4-BE49-F238E27FC236}">
                      <a16:creationId xmlns:a16="http://schemas.microsoft.com/office/drawing/2014/main" id="{882D986C-F9E8-0B27-26B9-5C2AF711D86B}"/>
                    </a:ext>
                  </a:extLst>
                </p:cNvPr>
                <p:cNvSpPr txBox="1"/>
                <p:nvPr/>
              </p:nvSpPr>
              <p:spPr>
                <a:xfrm>
                  <a:off x="4469791" y="6957957"/>
                  <a:ext cx="18406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75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2196B8D3-05EE-378F-B4A7-341585710F0A}"/>
                    </a:ext>
                  </a:extLst>
                </p:cNvPr>
                <p:cNvSpPr txBox="1"/>
                <p:nvPr/>
              </p:nvSpPr>
              <p:spPr>
                <a:xfrm>
                  <a:off x="4469791" y="6763363"/>
                  <a:ext cx="184069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5491485A-D3D5-19E3-807E-5C3E504C5C98}"/>
                    </a:ext>
                  </a:extLst>
                </p:cNvPr>
                <p:cNvSpPr txBox="1"/>
                <p:nvPr/>
              </p:nvSpPr>
              <p:spPr>
                <a:xfrm>
                  <a:off x="5021109" y="6751111"/>
                  <a:ext cx="487223" cy="6982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0.029</a:t>
                  </a:r>
                  <a:endParaRPr lang="zh-CN" altLang="en-US" sz="5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68D64DC8-680F-49FA-7906-07A901499E0C}"/>
                  </a:ext>
                </a:extLst>
              </p:cNvPr>
              <p:cNvSpPr txBox="1"/>
              <p:nvPr/>
            </p:nvSpPr>
            <p:spPr>
              <a:xfrm rot="16200000">
                <a:off x="4550074" y="2107906"/>
                <a:ext cx="81996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expressio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E80F919A-E876-E2C3-210F-C06827D68D79}"/>
                </a:ext>
              </a:extLst>
            </p:cNvPr>
            <p:cNvSpPr txBox="1"/>
            <p:nvPr/>
          </p:nvSpPr>
          <p:spPr>
            <a:xfrm>
              <a:off x="515768" y="296456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A9C820EA-CE55-6793-F210-7C14EC82306D}"/>
                </a:ext>
              </a:extLst>
            </p:cNvPr>
            <p:cNvSpPr txBox="1"/>
            <p:nvPr/>
          </p:nvSpPr>
          <p:spPr>
            <a:xfrm>
              <a:off x="515768" y="2358823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50FFFD8F-72CE-2DAA-AF65-53970F09A51A}"/>
                </a:ext>
              </a:extLst>
            </p:cNvPr>
            <p:cNvSpPr txBox="1"/>
            <p:nvPr/>
          </p:nvSpPr>
          <p:spPr>
            <a:xfrm>
              <a:off x="5029893" y="2358823"/>
              <a:ext cx="275879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E3E50EB8-8D60-1969-4F3A-7D558F072669}"/>
                </a:ext>
              </a:extLst>
            </p:cNvPr>
            <p:cNvSpPr txBox="1"/>
            <p:nvPr/>
          </p:nvSpPr>
          <p:spPr>
            <a:xfrm>
              <a:off x="2006872" y="2358823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809C1EF2-2ECC-6628-8A7E-418049321E85}"/>
                </a:ext>
              </a:extLst>
            </p:cNvPr>
            <p:cNvSpPr txBox="1"/>
            <p:nvPr/>
          </p:nvSpPr>
          <p:spPr>
            <a:xfrm>
              <a:off x="3646477" y="2358823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66272F4F-BB5E-3B18-1483-BFC3D6E58CCA}"/>
                </a:ext>
              </a:extLst>
            </p:cNvPr>
            <p:cNvSpPr txBox="1"/>
            <p:nvPr/>
          </p:nvSpPr>
          <p:spPr>
            <a:xfrm>
              <a:off x="3693943" y="296456"/>
              <a:ext cx="275879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9" name="组合 118">
              <a:extLst>
                <a:ext uri="{FF2B5EF4-FFF2-40B4-BE49-F238E27FC236}">
                  <a16:creationId xmlns:a16="http://schemas.microsoft.com/office/drawing/2014/main" id="{98F5A5FE-1369-49AB-8234-439BF6DF1B9B}"/>
                </a:ext>
              </a:extLst>
            </p:cNvPr>
            <p:cNvGrpSpPr/>
            <p:nvPr/>
          </p:nvGrpSpPr>
          <p:grpSpPr>
            <a:xfrm>
              <a:off x="515768" y="3956624"/>
              <a:ext cx="6782588" cy="3745746"/>
              <a:chOff x="515768" y="3956624"/>
              <a:chExt cx="6782588" cy="3745746"/>
            </a:xfrm>
          </p:grpSpPr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2B47C877-EC2C-C60E-46CA-291ADE173551}"/>
                  </a:ext>
                </a:extLst>
              </p:cNvPr>
              <p:cNvSpPr txBox="1"/>
              <p:nvPr/>
            </p:nvSpPr>
            <p:spPr>
              <a:xfrm>
                <a:off x="515768" y="3956624"/>
                <a:ext cx="303083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1A347640-31C4-4A3F-AC2A-AC5D99CD9DDC}"/>
                  </a:ext>
                </a:extLst>
              </p:cNvPr>
              <p:cNvSpPr txBox="1"/>
              <p:nvPr/>
            </p:nvSpPr>
            <p:spPr>
              <a:xfrm>
                <a:off x="2955802" y="3956624"/>
                <a:ext cx="303083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5" name="组合 94">
                <a:extLst>
                  <a:ext uri="{FF2B5EF4-FFF2-40B4-BE49-F238E27FC236}">
                    <a16:creationId xmlns:a16="http://schemas.microsoft.com/office/drawing/2014/main" id="{4312D097-2DC4-4496-DBB9-5A475B882097}"/>
                  </a:ext>
                </a:extLst>
              </p:cNvPr>
              <p:cNvGrpSpPr/>
              <p:nvPr/>
            </p:nvGrpSpPr>
            <p:grpSpPr>
              <a:xfrm>
                <a:off x="745376" y="4222953"/>
                <a:ext cx="2126256" cy="3479417"/>
                <a:chOff x="818802" y="3802405"/>
                <a:chExt cx="2367458" cy="3870574"/>
              </a:xfrm>
            </p:grpSpPr>
            <p:pic>
              <p:nvPicPr>
                <p:cNvPr id="96" name="图片 95">
                  <a:extLst>
                    <a:ext uri="{FF2B5EF4-FFF2-40B4-BE49-F238E27FC236}">
                      <a16:creationId xmlns:a16="http://schemas.microsoft.com/office/drawing/2014/main" id="{8C53758E-3CCC-96FB-F480-CFB18B418CD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18802" y="3802405"/>
                  <a:ext cx="2367458" cy="3508986"/>
                </a:xfrm>
                <a:prstGeom prst="rect">
                  <a:avLst/>
                </a:prstGeom>
              </p:spPr>
            </p:pic>
            <p:cxnSp>
              <p:nvCxnSpPr>
                <p:cNvPr id="97" name="直接箭头连接符 96">
                  <a:extLst>
                    <a:ext uri="{FF2B5EF4-FFF2-40B4-BE49-F238E27FC236}">
                      <a16:creationId xmlns:a16="http://schemas.microsoft.com/office/drawing/2014/main" id="{AC61192F-BA3C-B225-6787-90AC6DDE2F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8802" y="7428322"/>
                  <a:ext cx="2032752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3" name="文本框 112">
                  <a:extLst>
                    <a:ext uri="{FF2B5EF4-FFF2-40B4-BE49-F238E27FC236}">
                      <a16:creationId xmlns:a16="http://schemas.microsoft.com/office/drawing/2014/main" id="{3B8A561B-7488-8801-0071-1465B367C9F1}"/>
                    </a:ext>
                  </a:extLst>
                </p:cNvPr>
                <p:cNvSpPr txBox="1"/>
                <p:nvPr/>
              </p:nvSpPr>
              <p:spPr>
                <a:xfrm>
                  <a:off x="1286804" y="7395980"/>
                  <a:ext cx="142477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seudotime</a:t>
                  </a:r>
                  <a:endParaRPr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4" name="组合 113">
                <a:extLst>
                  <a:ext uri="{FF2B5EF4-FFF2-40B4-BE49-F238E27FC236}">
                    <a16:creationId xmlns:a16="http://schemas.microsoft.com/office/drawing/2014/main" id="{0C65EF75-3812-63AD-09D4-82D32E01EDA1}"/>
                  </a:ext>
                </a:extLst>
              </p:cNvPr>
              <p:cNvGrpSpPr/>
              <p:nvPr/>
            </p:nvGrpSpPr>
            <p:grpSpPr>
              <a:xfrm>
                <a:off x="3073148" y="4230594"/>
                <a:ext cx="4225208" cy="3045577"/>
                <a:chOff x="1863090" y="3403789"/>
                <a:chExt cx="4225208" cy="3045577"/>
              </a:xfrm>
            </p:grpSpPr>
            <p:pic>
              <p:nvPicPr>
                <p:cNvPr id="115" name="图片 114">
                  <a:extLst>
                    <a:ext uri="{FF2B5EF4-FFF2-40B4-BE49-F238E27FC236}">
                      <a16:creationId xmlns:a16="http://schemas.microsoft.com/office/drawing/2014/main" id="{6C5ED060-AD52-EDFE-7B52-6476FDC54B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933"/>
                <a:stretch/>
              </p:blipFill>
              <p:spPr>
                <a:xfrm>
                  <a:off x="4080510" y="3403789"/>
                  <a:ext cx="2007788" cy="2905572"/>
                </a:xfrm>
                <a:prstGeom prst="rect">
                  <a:avLst/>
                </a:prstGeom>
              </p:spPr>
            </p:pic>
            <p:sp>
              <p:nvSpPr>
                <p:cNvPr id="116" name="文本框 115">
                  <a:extLst>
                    <a:ext uri="{FF2B5EF4-FFF2-40B4-BE49-F238E27FC236}">
                      <a16:creationId xmlns:a16="http://schemas.microsoft.com/office/drawing/2014/main" id="{0B17EFAF-E4B0-9014-DB12-FE23F9111016}"/>
                    </a:ext>
                  </a:extLst>
                </p:cNvPr>
                <p:cNvSpPr txBox="1"/>
                <p:nvPr/>
              </p:nvSpPr>
              <p:spPr>
                <a:xfrm>
                  <a:off x="1863090" y="3506831"/>
                  <a:ext cx="2297430" cy="26455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itin catabolic process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une system process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flammatory response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ntimicrobial humoral immune response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ositive regulation of DBP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gative regulation of single-species biofilm formation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onse to interleukin-6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onse to glucocorticoid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onse to hypoxia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eratinocyte differentiation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ular response to hydrogen peroxide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ytoplasmic translation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nate immune response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dherens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junction assembly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duction of MM involved in inflammatory response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pithelial cell differentiation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epinephrine metabolic process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tochondrion organization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utrophil homeostasis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onse to drug</a:t>
                  </a:r>
                </a:p>
              </p:txBody>
            </p:sp>
            <p:sp>
              <p:nvSpPr>
                <p:cNvPr id="117" name="文本框 116">
                  <a:extLst>
                    <a:ext uri="{FF2B5EF4-FFF2-40B4-BE49-F238E27FC236}">
                      <a16:creationId xmlns:a16="http://schemas.microsoft.com/office/drawing/2014/main" id="{FCDE3417-A24B-D6A5-AD1A-4A01556F3DDB}"/>
                    </a:ext>
                  </a:extLst>
                </p:cNvPr>
                <p:cNvSpPr txBox="1"/>
                <p:nvPr/>
              </p:nvSpPr>
              <p:spPr>
                <a:xfrm>
                  <a:off x="2718641" y="6341644"/>
                  <a:ext cx="246567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BP: dopamine biosynthetic process; MM: molecular mediator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00" name="文本框 24">
            <a:extLst>
              <a:ext uri="{FF2B5EF4-FFF2-40B4-BE49-F238E27FC236}">
                <a16:creationId xmlns:a16="http://schemas.microsoft.com/office/drawing/2014/main" id="{B5346B1A-8924-B5B0-6349-D31A12B1F1FE}"/>
              </a:ext>
            </a:extLst>
          </p:cNvPr>
          <p:cNvSpPr txBox="1"/>
          <p:nvPr/>
        </p:nvSpPr>
        <p:spPr>
          <a:xfrm>
            <a:off x="297797" y="7676981"/>
            <a:ext cx="7068169" cy="234622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4. Altered subsets of club cells during OVA-induced allergic inflammation.</a:t>
            </a: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seudotim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developmental trajectory analysis from Monocle2 depicting relations between proliferative club, apoptotic club, quiescent club, and goblet cells. (B)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seudotime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abelling of goblet cells and three club cells subsets. (C) Club cells subtypes percentage in total airway cells. (D) Single-cell RNA seq analysis of Gdpd2 expression in each club cells subset. (E, F) Single-cell RNA seq analysis of Gdpd2 expression in apoptotic (E) or proliferative (F) club cells. Differences were analyzed by the two-sided Wilcoxon rank-sum test based on the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ndMarkers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function of the Seurat package, p &lt; 0.05 were considered to be statistically significant. (G) Expression heatmap showing top 50 genes with the lowest q value along the cell differentiation. (H) Top 20 pathway enrichment results of genes altered in differentiation process.</a:t>
            </a:r>
          </a:p>
        </p:txBody>
      </p:sp>
    </p:spTree>
    <p:extLst>
      <p:ext uri="{BB962C8B-B14F-4D97-AF65-F5344CB8AC3E}">
        <p14:creationId xmlns:p14="http://schemas.microsoft.com/office/powerpoint/2010/main" val="244206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b="1" dirty="0">
            <a:solidFill>
              <a:srgbClr val="00B050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86</TotalTime>
  <Words>340</Words>
  <Application>Microsoft Office PowerPoint</Application>
  <PresentationFormat>自定义</PresentationFormat>
  <Paragraphs>9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vel</dc:creator>
  <cp:lastModifiedBy>岳青</cp:lastModifiedBy>
  <cp:revision>1574</cp:revision>
  <cp:lastPrinted>2020-08-07T09:00:00Z</cp:lastPrinted>
  <dcterms:created xsi:type="dcterms:W3CDTF">2019-12-31T01:32:00Z</dcterms:created>
  <dcterms:modified xsi:type="dcterms:W3CDTF">2023-04-16T02:39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F6B2A8FAB1314C0CA40D9C07A9579253</vt:lpwstr>
  </property>
</Properties>
</file>